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CONIO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1"/>
                <c:pt idx="0">
                  <c:v>2.61223</c:v>
                </c:pt>
                <c:pt idx="1">
                  <c:v>2.57398</c:v>
                </c:pt>
                <c:pt idx="2">
                  <c:v>2.52291</c:v>
                </c:pt>
                <c:pt idx="3">
                  <c:v>2.45936</c:v>
                </c:pt>
                <c:pt idx="4">
                  <c:v>2.38707</c:v>
                </c:pt>
                <c:pt idx="5">
                  <c:v>2.30741</c:v>
                </c:pt>
                <c:pt idx="6">
                  <c:v>2.22759</c:v>
                </c:pt>
                <c:pt idx="7">
                  <c:v>2.14861</c:v>
                </c:pt>
                <c:pt idx="8">
                  <c:v>2.06901</c:v>
                </c:pt>
                <c:pt idx="9">
                  <c:v>1.99223</c:v>
                </c:pt>
                <c:pt idx="10">
                  <c:v>1.92128</c:v>
                </c:pt>
                <c:pt idx="11">
                  <c:v>1.85819</c:v>
                </c:pt>
                <c:pt idx="12">
                  <c:v>1.80108</c:v>
                </c:pt>
                <c:pt idx="13">
                  <c:v>1.74951</c:v>
                </c:pt>
                <c:pt idx="14">
                  <c:v>1.70255</c:v>
                </c:pt>
                <c:pt idx="15">
                  <c:v>1.66225</c:v>
                </c:pt>
                <c:pt idx="16">
                  <c:v>1.62667</c:v>
                </c:pt>
                <c:pt idx="17">
                  <c:v>1.59587</c:v>
                </c:pt>
                <c:pt idx="18">
                  <c:v>1.56989</c:v>
                </c:pt>
                <c:pt idx="19">
                  <c:v>1.5493</c:v>
                </c:pt>
                <c:pt idx="20">
                  <c:v>1.53364</c:v>
                </c:pt>
                <c:pt idx="21">
                  <c:v>1.52451</c:v>
                </c:pt>
                <c:pt idx="22">
                  <c:v>1.52043</c:v>
                </c:pt>
                <c:pt idx="23">
                  <c:v>1.52145</c:v>
                </c:pt>
                <c:pt idx="24">
                  <c:v>1.52917</c:v>
                </c:pt>
                <c:pt idx="25">
                  <c:v>1.55148</c:v>
                </c:pt>
                <c:pt idx="26">
                  <c:v>1.5932</c:v>
                </c:pt>
                <c:pt idx="27">
                  <c:v>1.65662</c:v>
                </c:pt>
                <c:pt idx="28">
                  <c:v>1.73672</c:v>
                </c:pt>
                <c:pt idx="29">
                  <c:v>1.83469</c:v>
                </c:pt>
                <c:pt idx="30">
                  <c:v>1.94121</c:v>
                </c:pt>
                <c:pt idx="31">
                  <c:v>2.04998</c:v>
                </c:pt>
                <c:pt idx="32">
                  <c:v>2.14665</c:v>
                </c:pt>
                <c:pt idx="33">
                  <c:v>2.21828</c:v>
                </c:pt>
                <c:pt idx="34">
                  <c:v>2.24642</c:v>
                </c:pt>
                <c:pt idx="35">
                  <c:v>2.22687</c:v>
                </c:pt>
                <c:pt idx="36">
                  <c:v>2.19312</c:v>
                </c:pt>
                <c:pt idx="37">
                  <c:v>2.19805</c:v>
                </c:pt>
                <c:pt idx="38">
                  <c:v>2.24854</c:v>
                </c:pt>
                <c:pt idx="39">
                  <c:v>2.31565</c:v>
                </c:pt>
                <c:pt idx="40">
                  <c:v>2.38177</c:v>
                </c:pt>
                <c:pt idx="41">
                  <c:v>2.448</c:v>
                </c:pt>
                <c:pt idx="42">
                  <c:v>2.51267</c:v>
                </c:pt>
                <c:pt idx="43">
                  <c:v>2.57853</c:v>
                </c:pt>
                <c:pt idx="44">
                  <c:v>2.64504</c:v>
                </c:pt>
                <c:pt idx="45">
                  <c:v>2.71246</c:v>
                </c:pt>
                <c:pt idx="46">
                  <c:v>2.78054</c:v>
                </c:pt>
                <c:pt idx="47">
                  <c:v>2.84676</c:v>
                </c:pt>
                <c:pt idx="48">
                  <c:v>2.91165</c:v>
                </c:pt>
                <c:pt idx="49">
                  <c:v>2.97606</c:v>
                </c:pt>
                <c:pt idx="50">
                  <c:v>3.04052</c:v>
                </c:pt>
                <c:pt idx="51">
                  <c:v>3.10561</c:v>
                </c:pt>
                <c:pt idx="52">
                  <c:v>3.17388</c:v>
                </c:pt>
                <c:pt idx="53">
                  <c:v>3.24648</c:v>
                </c:pt>
                <c:pt idx="54">
                  <c:v>3.32547</c:v>
                </c:pt>
                <c:pt idx="55">
                  <c:v>3.41432</c:v>
                </c:pt>
                <c:pt idx="56">
                  <c:v>3.51541</c:v>
                </c:pt>
                <c:pt idx="57">
                  <c:v>3.63232</c:v>
                </c:pt>
                <c:pt idx="58">
                  <c:v>3.76979</c:v>
                </c:pt>
                <c:pt idx="59">
                  <c:v>3.93351</c:v>
                </c:pt>
                <c:pt idx="60">
                  <c:v>4.12923</c:v>
                </c:pt>
                <c:pt idx="61">
                  <c:v>4.36393</c:v>
                </c:pt>
                <c:pt idx="62">
                  <c:v>4.64861</c:v>
                </c:pt>
                <c:pt idx="63">
                  <c:v>4.995</c:v>
                </c:pt>
                <c:pt idx="64">
                  <c:v>5.41525</c:v>
                </c:pt>
                <c:pt idx="65">
                  <c:v>5.92694</c:v>
                </c:pt>
                <c:pt idx="66">
                  <c:v>6.54921</c:v>
                </c:pt>
                <c:pt idx="67">
                  <c:v>7.29634</c:v>
                </c:pt>
                <c:pt idx="68">
                  <c:v>8.17299</c:v>
                </c:pt>
                <c:pt idx="69">
                  <c:v>9.17905</c:v>
                </c:pt>
                <c:pt idx="70">
                  <c:v>10.301</c:v>
                </c:pt>
                <c:pt idx="71">
                  <c:v>11.5015</c:v>
                </c:pt>
                <c:pt idx="72">
                  <c:v>12.7113</c:v>
                </c:pt>
                <c:pt idx="73">
                  <c:v>13.8336</c:v>
                </c:pt>
                <c:pt idx="74">
                  <c:v>14.7626</c:v>
                </c:pt>
                <c:pt idx="75">
                  <c:v>15.4061</c:v>
                </c:pt>
                <c:pt idx="76">
                  <c:v>15.7013</c:v>
                </c:pt>
                <c:pt idx="77">
                  <c:v>15.634</c:v>
                </c:pt>
                <c:pt idx="78">
                  <c:v>15.251</c:v>
                </c:pt>
                <c:pt idx="79">
                  <c:v>14.6426</c:v>
                </c:pt>
                <c:pt idx="80">
                  <c:v>13.9095</c:v>
                </c:pt>
                <c:pt idx="81">
                  <c:v>13.1392</c:v>
                </c:pt>
                <c:pt idx="82">
                  <c:v>12.3954</c:v>
                </c:pt>
                <c:pt idx="83">
                  <c:v>11.7175</c:v>
                </c:pt>
                <c:pt idx="84">
                  <c:v>11.1288</c:v>
                </c:pt>
                <c:pt idx="85">
                  <c:v>10.6362</c:v>
                </c:pt>
                <c:pt idx="86">
                  <c:v>10.2458</c:v>
                </c:pt>
                <c:pt idx="87">
                  <c:v>9.97892</c:v>
                </c:pt>
                <c:pt idx="88">
                  <c:v>9.80855</c:v>
                </c:pt>
                <c:pt idx="89">
                  <c:v>9.64744</c:v>
                </c:pt>
                <c:pt idx="90">
                  <c:v>9.41485</c:v>
                </c:pt>
                <c:pt idx="91">
                  <c:v>9.10456</c:v>
                </c:pt>
                <c:pt idx="92">
                  <c:v>8.72911</c:v>
                </c:pt>
                <c:pt idx="93">
                  <c:v>8.27796</c:v>
                </c:pt>
                <c:pt idx="94">
                  <c:v>7.73253</c:v>
                </c:pt>
                <c:pt idx="95">
                  <c:v>7.10429</c:v>
                </c:pt>
                <c:pt idx="96">
                  <c:v>6.43531</c:v>
                </c:pt>
                <c:pt idx="97">
                  <c:v>5.76271</c:v>
                </c:pt>
                <c:pt idx="98">
                  <c:v>5.10885</c:v>
                </c:pt>
                <c:pt idx="99">
                  <c:v>4.48713</c:v>
                </c:pt>
                <c:pt idx="100">
                  <c:v>3.91048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5890625"/>
        <c:axId val="22031082"/>
      </c:lineChart>
      <c:catAx>
        <c:axId val="5890625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2031082"/>
        <c:crosses val="autoZero"/>
        <c:auto val="1"/>
        <c:lblAlgn val="ctr"/>
        <c:lblOffset val="100"/>
        <c:noMultiLvlLbl val="0"/>
      </c:catAx>
      <c:valAx>
        <c:axId val="22031082"/>
        <c:scaling>
          <c:orientation val="minMax"/>
          <c:max val="3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Specific Heat (Kcal/Mol*K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5890625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EPICHLOE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1"/>
                <c:pt idx="0">
                  <c:v>0.694498</c:v>
                </c:pt>
                <c:pt idx="1">
                  <c:v>0.679829</c:v>
                </c:pt>
                <c:pt idx="2">
                  <c:v>0.665035</c:v>
                </c:pt>
                <c:pt idx="3">
                  <c:v>0.650116</c:v>
                </c:pt>
                <c:pt idx="4">
                  <c:v>0.637971</c:v>
                </c:pt>
                <c:pt idx="5">
                  <c:v>0.628631</c:v>
                </c:pt>
                <c:pt idx="6">
                  <c:v>0.619695</c:v>
                </c:pt>
                <c:pt idx="7">
                  <c:v>0.61361</c:v>
                </c:pt>
                <c:pt idx="8">
                  <c:v>0.609426</c:v>
                </c:pt>
                <c:pt idx="9">
                  <c:v>0.607166</c:v>
                </c:pt>
                <c:pt idx="10">
                  <c:v>0.611293</c:v>
                </c:pt>
                <c:pt idx="11">
                  <c:v>0.620389</c:v>
                </c:pt>
                <c:pt idx="12">
                  <c:v>0.634009</c:v>
                </c:pt>
                <c:pt idx="13">
                  <c:v>0.654696</c:v>
                </c:pt>
                <c:pt idx="14">
                  <c:v>0.682021</c:v>
                </c:pt>
                <c:pt idx="15">
                  <c:v>0.716054</c:v>
                </c:pt>
                <c:pt idx="16">
                  <c:v>0.76039</c:v>
                </c:pt>
                <c:pt idx="17">
                  <c:v>0.813618</c:v>
                </c:pt>
                <c:pt idx="18">
                  <c:v>0.876842</c:v>
                </c:pt>
                <c:pt idx="19">
                  <c:v>0.948632</c:v>
                </c:pt>
                <c:pt idx="20">
                  <c:v>1.03265</c:v>
                </c:pt>
                <c:pt idx="21">
                  <c:v>1.12389</c:v>
                </c:pt>
                <c:pt idx="22">
                  <c:v>1.22293</c:v>
                </c:pt>
                <c:pt idx="23">
                  <c:v>1.3252</c:v>
                </c:pt>
                <c:pt idx="24">
                  <c:v>1.42761</c:v>
                </c:pt>
                <c:pt idx="25">
                  <c:v>1.5286</c:v>
                </c:pt>
                <c:pt idx="26">
                  <c:v>1.62241</c:v>
                </c:pt>
                <c:pt idx="27">
                  <c:v>1.7053</c:v>
                </c:pt>
                <c:pt idx="28">
                  <c:v>1.774</c:v>
                </c:pt>
                <c:pt idx="29">
                  <c:v>1.82574</c:v>
                </c:pt>
                <c:pt idx="30">
                  <c:v>1.8561</c:v>
                </c:pt>
                <c:pt idx="31">
                  <c:v>1.86487</c:v>
                </c:pt>
                <c:pt idx="32">
                  <c:v>1.85078</c:v>
                </c:pt>
                <c:pt idx="33">
                  <c:v>1.812</c:v>
                </c:pt>
                <c:pt idx="34">
                  <c:v>1.75096</c:v>
                </c:pt>
                <c:pt idx="35">
                  <c:v>1.6723</c:v>
                </c:pt>
                <c:pt idx="36">
                  <c:v>1.5823</c:v>
                </c:pt>
                <c:pt idx="37">
                  <c:v>1.4879</c:v>
                </c:pt>
                <c:pt idx="38">
                  <c:v>1.39612</c:v>
                </c:pt>
                <c:pt idx="39">
                  <c:v>1.30861</c:v>
                </c:pt>
                <c:pt idx="40">
                  <c:v>1.22543</c:v>
                </c:pt>
                <c:pt idx="41">
                  <c:v>1.14936</c:v>
                </c:pt>
                <c:pt idx="42">
                  <c:v>1.08102</c:v>
                </c:pt>
                <c:pt idx="43">
                  <c:v>1.02325</c:v>
                </c:pt>
                <c:pt idx="44">
                  <c:v>0.973672</c:v>
                </c:pt>
                <c:pt idx="45">
                  <c:v>0.934299</c:v>
                </c:pt>
                <c:pt idx="46">
                  <c:v>0.905791</c:v>
                </c:pt>
                <c:pt idx="47">
                  <c:v>0.886855</c:v>
                </c:pt>
                <c:pt idx="48">
                  <c:v>0.877864</c:v>
                </c:pt>
                <c:pt idx="49">
                  <c:v>0.878632</c:v>
                </c:pt>
                <c:pt idx="50">
                  <c:v>0.889812</c:v>
                </c:pt>
                <c:pt idx="51">
                  <c:v>0.910089</c:v>
                </c:pt>
                <c:pt idx="52">
                  <c:v>0.941815</c:v>
                </c:pt>
                <c:pt idx="53">
                  <c:v>0.985093</c:v>
                </c:pt>
                <c:pt idx="54">
                  <c:v>1.04174</c:v>
                </c:pt>
                <c:pt idx="55">
                  <c:v>1.11245</c:v>
                </c:pt>
                <c:pt idx="56">
                  <c:v>1.1985</c:v>
                </c:pt>
                <c:pt idx="57">
                  <c:v>1.30462</c:v>
                </c:pt>
                <c:pt idx="58">
                  <c:v>1.43533</c:v>
                </c:pt>
                <c:pt idx="59">
                  <c:v>1.59344</c:v>
                </c:pt>
                <c:pt idx="60">
                  <c:v>1.78764</c:v>
                </c:pt>
                <c:pt idx="61">
                  <c:v>2.02667</c:v>
                </c:pt>
                <c:pt idx="62">
                  <c:v>2.32452</c:v>
                </c:pt>
                <c:pt idx="63">
                  <c:v>2.69783</c:v>
                </c:pt>
                <c:pt idx="64">
                  <c:v>3.17063</c:v>
                </c:pt>
                <c:pt idx="65">
                  <c:v>3.77252</c:v>
                </c:pt>
                <c:pt idx="66">
                  <c:v>4.54293</c:v>
                </c:pt>
                <c:pt idx="67">
                  <c:v>5.52394</c:v>
                </c:pt>
                <c:pt idx="68">
                  <c:v>6.75203</c:v>
                </c:pt>
                <c:pt idx="69">
                  <c:v>8.24125</c:v>
                </c:pt>
                <c:pt idx="70">
                  <c:v>9.96137</c:v>
                </c:pt>
                <c:pt idx="71">
                  <c:v>11.8069</c:v>
                </c:pt>
                <c:pt idx="72">
                  <c:v>13.5881</c:v>
                </c:pt>
                <c:pt idx="73">
                  <c:v>15.0588</c:v>
                </c:pt>
                <c:pt idx="74">
                  <c:v>15.9984</c:v>
                </c:pt>
                <c:pt idx="75">
                  <c:v>16.3017</c:v>
                </c:pt>
                <c:pt idx="76">
                  <c:v>16.0213</c:v>
                </c:pt>
                <c:pt idx="77">
                  <c:v>15.3368</c:v>
                </c:pt>
                <c:pt idx="78">
                  <c:v>14.474</c:v>
                </c:pt>
                <c:pt idx="79">
                  <c:v>13.6226</c:v>
                </c:pt>
                <c:pt idx="80">
                  <c:v>12.8968</c:v>
                </c:pt>
                <c:pt idx="81">
                  <c:v>12.3406</c:v>
                </c:pt>
                <c:pt idx="82">
                  <c:v>11.9525</c:v>
                </c:pt>
                <c:pt idx="83">
                  <c:v>11.7077</c:v>
                </c:pt>
                <c:pt idx="84">
                  <c:v>11.5788</c:v>
                </c:pt>
                <c:pt idx="85">
                  <c:v>11.5375</c:v>
                </c:pt>
                <c:pt idx="86">
                  <c:v>11.5694</c:v>
                </c:pt>
                <c:pt idx="87">
                  <c:v>11.6835</c:v>
                </c:pt>
                <c:pt idx="88">
                  <c:v>11.8426</c:v>
                </c:pt>
                <c:pt idx="89">
                  <c:v>11.9545</c:v>
                </c:pt>
                <c:pt idx="90">
                  <c:v>11.941</c:v>
                </c:pt>
                <c:pt idx="91">
                  <c:v>11.8039</c:v>
                </c:pt>
                <c:pt idx="92">
                  <c:v>11.563</c:v>
                </c:pt>
                <c:pt idx="93">
                  <c:v>11.2098</c:v>
                </c:pt>
                <c:pt idx="94">
                  <c:v>10.7194</c:v>
                </c:pt>
                <c:pt idx="95">
                  <c:v>10.0918</c:v>
                </c:pt>
                <c:pt idx="96">
                  <c:v>9.36069</c:v>
                </c:pt>
                <c:pt idx="97">
                  <c:v>8.56429</c:v>
                </c:pt>
                <c:pt idx="98">
                  <c:v>7.73625</c:v>
                </c:pt>
                <c:pt idx="99">
                  <c:v>6.90668</c:v>
                </c:pt>
                <c:pt idx="100">
                  <c:v>6.10563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20920176"/>
        <c:axId val="32592601"/>
      </c:lineChart>
      <c:catAx>
        <c:axId val="20920176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32592601"/>
        <c:crosses val="autoZero"/>
        <c:auto val="1"/>
        <c:lblAlgn val="ctr"/>
        <c:lblOffset val="100"/>
        <c:noMultiLvlLbl val="0"/>
      </c:catAx>
      <c:valAx>
        <c:axId val="32592601"/>
        <c:scaling>
          <c:orientation val="minMax"/>
          <c:max val="3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Specific Heat (Kcal/Mol*K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0920176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GREMME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1"/>
                <c:pt idx="0">
                  <c:v>1.32898</c:v>
                </c:pt>
                <c:pt idx="1">
                  <c:v>1.26595</c:v>
                </c:pt>
                <c:pt idx="2">
                  <c:v>1.20628</c:v>
                </c:pt>
                <c:pt idx="3">
                  <c:v>1.14854</c:v>
                </c:pt>
                <c:pt idx="4">
                  <c:v>1.09325</c:v>
                </c:pt>
                <c:pt idx="5">
                  <c:v>1.04093</c:v>
                </c:pt>
                <c:pt idx="6">
                  <c:v>0.992583</c:v>
                </c:pt>
                <c:pt idx="7">
                  <c:v>0.947285</c:v>
                </c:pt>
                <c:pt idx="8">
                  <c:v>0.90703</c:v>
                </c:pt>
                <c:pt idx="9">
                  <c:v>0.868926</c:v>
                </c:pt>
                <c:pt idx="10">
                  <c:v>0.836454</c:v>
                </c:pt>
                <c:pt idx="11">
                  <c:v>0.813146</c:v>
                </c:pt>
                <c:pt idx="12">
                  <c:v>0.797111</c:v>
                </c:pt>
                <c:pt idx="13">
                  <c:v>0.783439</c:v>
                </c:pt>
                <c:pt idx="14">
                  <c:v>0.771656</c:v>
                </c:pt>
                <c:pt idx="15">
                  <c:v>0.762785</c:v>
                </c:pt>
                <c:pt idx="16">
                  <c:v>0.756356</c:v>
                </c:pt>
                <c:pt idx="17">
                  <c:v>0.753912</c:v>
                </c:pt>
                <c:pt idx="18">
                  <c:v>0.752957</c:v>
                </c:pt>
                <c:pt idx="19">
                  <c:v>0.760128</c:v>
                </c:pt>
                <c:pt idx="20">
                  <c:v>0.776021</c:v>
                </c:pt>
                <c:pt idx="21">
                  <c:v>0.798161</c:v>
                </c:pt>
                <c:pt idx="22">
                  <c:v>0.823521</c:v>
                </c:pt>
                <c:pt idx="23">
                  <c:v>0.856265</c:v>
                </c:pt>
                <c:pt idx="24">
                  <c:v>0.89543</c:v>
                </c:pt>
                <c:pt idx="25">
                  <c:v>0.940558</c:v>
                </c:pt>
                <c:pt idx="26">
                  <c:v>0.994837</c:v>
                </c:pt>
                <c:pt idx="27">
                  <c:v>1.06045</c:v>
                </c:pt>
                <c:pt idx="28">
                  <c:v>1.13645</c:v>
                </c:pt>
                <c:pt idx="29">
                  <c:v>1.22453</c:v>
                </c:pt>
                <c:pt idx="30">
                  <c:v>1.3322</c:v>
                </c:pt>
                <c:pt idx="31">
                  <c:v>1.51534</c:v>
                </c:pt>
                <c:pt idx="32">
                  <c:v>1.80076</c:v>
                </c:pt>
                <c:pt idx="33">
                  <c:v>2.1318</c:v>
                </c:pt>
                <c:pt idx="34">
                  <c:v>2.40818</c:v>
                </c:pt>
                <c:pt idx="35">
                  <c:v>2.58852</c:v>
                </c:pt>
                <c:pt idx="36">
                  <c:v>2.67886</c:v>
                </c:pt>
                <c:pt idx="37">
                  <c:v>2.69348</c:v>
                </c:pt>
                <c:pt idx="38">
                  <c:v>2.64844</c:v>
                </c:pt>
                <c:pt idx="39">
                  <c:v>2.54863</c:v>
                </c:pt>
                <c:pt idx="40">
                  <c:v>2.40635</c:v>
                </c:pt>
                <c:pt idx="41">
                  <c:v>2.23927</c:v>
                </c:pt>
                <c:pt idx="42">
                  <c:v>2.06751</c:v>
                </c:pt>
                <c:pt idx="43">
                  <c:v>1.90895</c:v>
                </c:pt>
                <c:pt idx="44">
                  <c:v>1.77921</c:v>
                </c:pt>
                <c:pt idx="45">
                  <c:v>1.68607</c:v>
                </c:pt>
                <c:pt idx="46">
                  <c:v>1.62041</c:v>
                </c:pt>
                <c:pt idx="47">
                  <c:v>1.56574</c:v>
                </c:pt>
                <c:pt idx="48">
                  <c:v>1.51407</c:v>
                </c:pt>
                <c:pt idx="49">
                  <c:v>1.46514</c:v>
                </c:pt>
                <c:pt idx="50">
                  <c:v>1.42122</c:v>
                </c:pt>
                <c:pt idx="51">
                  <c:v>1.38435</c:v>
                </c:pt>
                <c:pt idx="52">
                  <c:v>1.35517</c:v>
                </c:pt>
                <c:pt idx="53">
                  <c:v>1.33573</c:v>
                </c:pt>
                <c:pt idx="54">
                  <c:v>1.32585</c:v>
                </c:pt>
                <c:pt idx="55">
                  <c:v>1.32819</c:v>
                </c:pt>
                <c:pt idx="56">
                  <c:v>1.34142</c:v>
                </c:pt>
                <c:pt idx="57">
                  <c:v>1.37025</c:v>
                </c:pt>
                <c:pt idx="58">
                  <c:v>1.41309</c:v>
                </c:pt>
                <c:pt idx="59">
                  <c:v>1.47268</c:v>
                </c:pt>
                <c:pt idx="60">
                  <c:v>1.5506</c:v>
                </c:pt>
                <c:pt idx="61">
                  <c:v>1.65053</c:v>
                </c:pt>
                <c:pt idx="62">
                  <c:v>1.77543</c:v>
                </c:pt>
                <c:pt idx="63">
                  <c:v>1.93021</c:v>
                </c:pt>
                <c:pt idx="64">
                  <c:v>2.12027</c:v>
                </c:pt>
                <c:pt idx="65">
                  <c:v>2.35197</c:v>
                </c:pt>
                <c:pt idx="66">
                  <c:v>2.63615</c:v>
                </c:pt>
                <c:pt idx="67">
                  <c:v>2.98619</c:v>
                </c:pt>
                <c:pt idx="68">
                  <c:v>3.41825</c:v>
                </c:pt>
                <c:pt idx="69">
                  <c:v>3.95214</c:v>
                </c:pt>
                <c:pt idx="70">
                  <c:v>4.61371</c:v>
                </c:pt>
                <c:pt idx="71">
                  <c:v>5.43211</c:v>
                </c:pt>
                <c:pt idx="72">
                  <c:v>6.43515</c:v>
                </c:pt>
                <c:pt idx="73">
                  <c:v>7.6419</c:v>
                </c:pt>
                <c:pt idx="74">
                  <c:v>9.05242</c:v>
                </c:pt>
                <c:pt idx="75">
                  <c:v>10.6289</c:v>
                </c:pt>
                <c:pt idx="76">
                  <c:v>12.2772</c:v>
                </c:pt>
                <c:pt idx="77">
                  <c:v>13.8474</c:v>
                </c:pt>
                <c:pt idx="78">
                  <c:v>15.1666</c:v>
                </c:pt>
                <c:pt idx="79">
                  <c:v>16.0894</c:v>
                </c:pt>
                <c:pt idx="80">
                  <c:v>16.5427</c:v>
                </c:pt>
                <c:pt idx="81">
                  <c:v>16.5457</c:v>
                </c:pt>
                <c:pt idx="82">
                  <c:v>16.1873</c:v>
                </c:pt>
                <c:pt idx="83">
                  <c:v>15.5826</c:v>
                </c:pt>
                <c:pt idx="84">
                  <c:v>14.8367</c:v>
                </c:pt>
                <c:pt idx="85">
                  <c:v>14.0192</c:v>
                </c:pt>
                <c:pt idx="86">
                  <c:v>13.173</c:v>
                </c:pt>
                <c:pt idx="87">
                  <c:v>12.3384</c:v>
                </c:pt>
                <c:pt idx="88">
                  <c:v>11.5305</c:v>
                </c:pt>
                <c:pt idx="89">
                  <c:v>10.736</c:v>
                </c:pt>
                <c:pt idx="90">
                  <c:v>9.95043</c:v>
                </c:pt>
                <c:pt idx="91">
                  <c:v>9.23373</c:v>
                </c:pt>
                <c:pt idx="92">
                  <c:v>8.67802</c:v>
                </c:pt>
                <c:pt idx="93">
                  <c:v>8.27172</c:v>
                </c:pt>
                <c:pt idx="94">
                  <c:v>7.90183</c:v>
                </c:pt>
                <c:pt idx="95">
                  <c:v>7.47811</c:v>
                </c:pt>
                <c:pt idx="96">
                  <c:v>7.01442</c:v>
                </c:pt>
                <c:pt idx="97">
                  <c:v>6.54372</c:v>
                </c:pt>
                <c:pt idx="98">
                  <c:v>6.09542</c:v>
                </c:pt>
                <c:pt idx="99">
                  <c:v>5.68968</c:v>
                </c:pt>
                <c:pt idx="100">
                  <c:v>5.33967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76698113"/>
        <c:axId val="52065459"/>
      </c:lineChart>
      <c:catAx>
        <c:axId val="76698113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52065459"/>
        <c:crosses val="autoZero"/>
        <c:auto val="1"/>
        <c:lblAlgn val="ctr"/>
        <c:lblOffset val="100"/>
        <c:noMultiLvlLbl val="0"/>
      </c:catAx>
      <c:valAx>
        <c:axId val="52065459"/>
        <c:scaling>
          <c:orientation val="minMax"/>
          <c:max val="3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Specific Heat (Kcal/Mol*K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76698113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CONIO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0"/>
                <c:pt idx="0">
                  <c:v>1.0638E-005</c:v>
                </c:pt>
                <c:pt idx="1">
                  <c:v>1.1239E-005</c:v>
                </c:pt>
                <c:pt idx="2">
                  <c:v>1.1872E-005</c:v>
                </c:pt>
                <c:pt idx="3">
                  <c:v>1.2536E-005</c:v>
                </c:pt>
                <c:pt idx="4">
                  <c:v>1.3235E-005</c:v>
                </c:pt>
                <c:pt idx="5">
                  <c:v>1.397E-005</c:v>
                </c:pt>
                <c:pt idx="6">
                  <c:v>1.4743E-005</c:v>
                </c:pt>
                <c:pt idx="7">
                  <c:v>1.5555E-005</c:v>
                </c:pt>
                <c:pt idx="8">
                  <c:v>1.6409E-005</c:v>
                </c:pt>
                <c:pt idx="9">
                  <c:v>1.7307E-005</c:v>
                </c:pt>
                <c:pt idx="10">
                  <c:v>1.8252E-005</c:v>
                </c:pt>
                <c:pt idx="11">
                  <c:v>1.9245E-005</c:v>
                </c:pt>
                <c:pt idx="12">
                  <c:v>2.029E-005</c:v>
                </c:pt>
                <c:pt idx="13">
                  <c:v>2.139E-005</c:v>
                </c:pt>
                <c:pt idx="14">
                  <c:v>2.2547E-005</c:v>
                </c:pt>
                <c:pt idx="15">
                  <c:v>2.3765E-005</c:v>
                </c:pt>
                <c:pt idx="16">
                  <c:v>2.5048E-005</c:v>
                </c:pt>
                <c:pt idx="17">
                  <c:v>2.6399E-005</c:v>
                </c:pt>
                <c:pt idx="18">
                  <c:v>2.7822E-005</c:v>
                </c:pt>
                <c:pt idx="19">
                  <c:v>2.9321E-005</c:v>
                </c:pt>
                <c:pt idx="20">
                  <c:v>3.0902E-005</c:v>
                </c:pt>
                <c:pt idx="21">
                  <c:v>3.2569E-005</c:v>
                </c:pt>
                <c:pt idx="22">
                  <c:v>3.4328E-005</c:v>
                </c:pt>
                <c:pt idx="23">
                  <c:v>3.6184E-005</c:v>
                </c:pt>
                <c:pt idx="24">
                  <c:v>3.8145E-005</c:v>
                </c:pt>
                <c:pt idx="25">
                  <c:v>4.0215E-005</c:v>
                </c:pt>
                <c:pt idx="26">
                  <c:v>4.2404E-005</c:v>
                </c:pt>
                <c:pt idx="27">
                  <c:v>4.4719E-005</c:v>
                </c:pt>
                <c:pt idx="28">
                  <c:v>4.7168E-005</c:v>
                </c:pt>
                <c:pt idx="29">
                  <c:v>4.976E-005</c:v>
                </c:pt>
                <c:pt idx="30">
                  <c:v>5.2507E-005</c:v>
                </c:pt>
                <c:pt idx="31">
                  <c:v>5.5418E-005</c:v>
                </c:pt>
                <c:pt idx="32">
                  <c:v>5.8505E-005</c:v>
                </c:pt>
                <c:pt idx="33">
                  <c:v>6.1782E-005</c:v>
                </c:pt>
                <c:pt idx="34">
                  <c:v>6.5262E-005</c:v>
                </c:pt>
                <c:pt idx="35">
                  <c:v>6.8961E-005</c:v>
                </c:pt>
                <c:pt idx="36">
                  <c:v>7.2894E-005</c:v>
                </c:pt>
                <c:pt idx="37">
                  <c:v>7.7082E-005</c:v>
                </c:pt>
                <c:pt idx="38">
                  <c:v>8.1542E-005</c:v>
                </c:pt>
                <c:pt idx="39">
                  <c:v>8.6298E-005</c:v>
                </c:pt>
                <c:pt idx="40">
                  <c:v>9.1374E-005</c:v>
                </c:pt>
                <c:pt idx="41">
                  <c:v>9.6795E-005</c:v>
                </c:pt>
                <c:pt idx="42">
                  <c:v>0.00010259</c:v>
                </c:pt>
                <c:pt idx="43">
                  <c:v>0.0001088</c:v>
                </c:pt>
                <c:pt idx="44">
                  <c:v>0.00011545</c:v>
                </c:pt>
                <c:pt idx="45">
                  <c:v>0.00012259</c:v>
                </c:pt>
                <c:pt idx="46">
                  <c:v>0.00013026</c:v>
                </c:pt>
                <c:pt idx="47">
                  <c:v>0.00013852</c:v>
                </c:pt>
                <c:pt idx="48">
                  <c:v>0.00014742</c:v>
                </c:pt>
                <c:pt idx="49">
                  <c:v>0.00015704</c:v>
                </c:pt>
                <c:pt idx="50">
                  <c:v>0.00016745</c:v>
                </c:pt>
                <c:pt idx="51">
                  <c:v>0.00017874</c:v>
                </c:pt>
                <c:pt idx="52">
                  <c:v>0.00019104</c:v>
                </c:pt>
                <c:pt idx="53">
                  <c:v>0.00020445</c:v>
                </c:pt>
                <c:pt idx="54">
                  <c:v>0.00021914</c:v>
                </c:pt>
                <c:pt idx="55">
                  <c:v>0.00023529</c:v>
                </c:pt>
                <c:pt idx="56">
                  <c:v>0.00025311</c:v>
                </c:pt>
                <c:pt idx="57">
                  <c:v>0.00027287</c:v>
                </c:pt>
                <c:pt idx="58">
                  <c:v>0.0002949</c:v>
                </c:pt>
                <c:pt idx="59">
                  <c:v>0.00031957</c:v>
                </c:pt>
                <c:pt idx="60">
                  <c:v>0.0003474</c:v>
                </c:pt>
                <c:pt idx="61">
                  <c:v>0.00037896</c:v>
                </c:pt>
                <c:pt idx="62">
                  <c:v>0.000415</c:v>
                </c:pt>
                <c:pt idx="63">
                  <c:v>0.00045643</c:v>
                </c:pt>
                <c:pt idx="64">
                  <c:v>0.00050439</c:v>
                </c:pt>
                <c:pt idx="65">
                  <c:v>0.00056027</c:v>
                </c:pt>
                <c:pt idx="66">
                  <c:v>0.00062578</c:v>
                </c:pt>
                <c:pt idx="67">
                  <c:v>0.000703</c:v>
                </c:pt>
                <c:pt idx="68">
                  <c:v>0.00079444</c:v>
                </c:pt>
                <c:pt idx="69">
                  <c:v>0.0009031</c:v>
                </c:pt>
                <c:pt idx="70">
                  <c:v>0.0010325</c:v>
                </c:pt>
                <c:pt idx="71">
                  <c:v>0.0011865</c:v>
                </c:pt>
                <c:pt idx="72">
                  <c:v>0.0013696</c:v>
                </c:pt>
                <c:pt idx="73">
                  <c:v>0.0015864</c:v>
                </c:pt>
                <c:pt idx="74">
                  <c:v>0.001842</c:v>
                </c:pt>
                <c:pt idx="75">
                  <c:v>0.0021418</c:v>
                </c:pt>
                <c:pt idx="76">
                  <c:v>0.0024936</c:v>
                </c:pt>
                <c:pt idx="77">
                  <c:v>0.002915</c:v>
                </c:pt>
                <c:pt idx="78">
                  <c:v>0.0034622</c:v>
                </c:pt>
                <c:pt idx="79">
                  <c:v>0.0043464</c:v>
                </c:pt>
                <c:pt idx="80">
                  <c:v>0.0064018</c:v>
                </c:pt>
                <c:pt idx="81">
                  <c:v>0.01284</c:v>
                </c:pt>
                <c:pt idx="82">
                  <c:v>0.033736</c:v>
                </c:pt>
                <c:pt idx="83">
                  <c:v>0.07953</c:v>
                </c:pt>
                <c:pt idx="84">
                  <c:v>0.10371</c:v>
                </c:pt>
                <c:pt idx="85">
                  <c:v>0.071487</c:v>
                </c:pt>
                <c:pt idx="86">
                  <c:v>0.06062</c:v>
                </c:pt>
                <c:pt idx="87">
                  <c:v>0.12104</c:v>
                </c:pt>
                <c:pt idx="88">
                  <c:v>0.20328</c:v>
                </c:pt>
                <c:pt idx="89">
                  <c:v>0.12864</c:v>
                </c:pt>
                <c:pt idx="90">
                  <c:v>0.049746</c:v>
                </c:pt>
                <c:pt idx="91">
                  <c:v>0.022508</c:v>
                </c:pt>
                <c:pt idx="92">
                  <c:v>0.012679</c:v>
                </c:pt>
                <c:pt idx="93">
                  <c:v>0.0082044</c:v>
                </c:pt>
                <c:pt idx="94">
                  <c:v>0.0057965</c:v>
                </c:pt>
                <c:pt idx="95">
                  <c:v>0.0043447</c:v>
                </c:pt>
                <c:pt idx="96">
                  <c:v>0.0033957</c:v>
                </c:pt>
                <c:pt idx="97">
                  <c:v>0.0027374</c:v>
                </c:pt>
                <c:pt idx="98">
                  <c:v>0.0022597</c:v>
                </c:pt>
                <c:pt idx="99">
                  <c:v>0.0019009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71730638"/>
        <c:axId val="3774204"/>
      </c:lineChart>
      <c:catAx>
        <c:axId val="71730638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3774204"/>
        <c:crosses val="autoZero"/>
        <c:auto val="1"/>
        <c:lblAlgn val="ctr"/>
        <c:lblOffset val="100"/>
        <c:noMultiLvlLbl val="0"/>
      </c:catAx>
      <c:valAx>
        <c:axId val="3774204"/>
        <c:scaling>
          <c:orientation val="minMax"/>
          <c:max val="0.3"/>
          <c:min val="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dθ/dT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71730638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GREMME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0"/>
                <c:pt idx="0">
                  <c:v>3.9207E-006</c:v>
                </c:pt>
                <c:pt idx="1">
                  <c:v>4.161E-006</c:v>
                </c:pt>
                <c:pt idx="2">
                  <c:v>4.415E-006</c:v>
                </c:pt>
                <c:pt idx="3">
                  <c:v>4.6835E-006</c:v>
                </c:pt>
                <c:pt idx="4">
                  <c:v>4.9672E-006</c:v>
                </c:pt>
                <c:pt idx="5">
                  <c:v>5.267E-006</c:v>
                </c:pt>
                <c:pt idx="6">
                  <c:v>5.5839E-006</c:v>
                </c:pt>
                <c:pt idx="7">
                  <c:v>5.9189E-006</c:v>
                </c:pt>
                <c:pt idx="8">
                  <c:v>6.2731E-006</c:v>
                </c:pt>
                <c:pt idx="9">
                  <c:v>6.6476E-006</c:v>
                </c:pt>
                <c:pt idx="10">
                  <c:v>7.0438E-006</c:v>
                </c:pt>
                <c:pt idx="11">
                  <c:v>7.4628E-006</c:v>
                </c:pt>
                <c:pt idx="12">
                  <c:v>7.9063E-006</c:v>
                </c:pt>
                <c:pt idx="13">
                  <c:v>8.3758E-006</c:v>
                </c:pt>
                <c:pt idx="14">
                  <c:v>8.8729E-006</c:v>
                </c:pt>
                <c:pt idx="15">
                  <c:v>9.3995E-006</c:v>
                </c:pt>
                <c:pt idx="16">
                  <c:v>9.9576E-006</c:v>
                </c:pt>
                <c:pt idx="17">
                  <c:v>1.0549E-005</c:v>
                </c:pt>
                <c:pt idx="18">
                  <c:v>1.1177E-005</c:v>
                </c:pt>
                <c:pt idx="19">
                  <c:v>1.1843E-005</c:v>
                </c:pt>
                <c:pt idx="20">
                  <c:v>1.2551E-005</c:v>
                </c:pt>
                <c:pt idx="21">
                  <c:v>1.3302E-005</c:v>
                </c:pt>
                <c:pt idx="22">
                  <c:v>1.4102E-005</c:v>
                </c:pt>
                <c:pt idx="23">
                  <c:v>1.4952E-005</c:v>
                </c:pt>
                <c:pt idx="24">
                  <c:v>1.5858E-005</c:v>
                </c:pt>
                <c:pt idx="25">
                  <c:v>1.6823E-005</c:v>
                </c:pt>
                <c:pt idx="26">
                  <c:v>1.7853E-005</c:v>
                </c:pt>
                <c:pt idx="27">
                  <c:v>1.8951E-005</c:v>
                </c:pt>
                <c:pt idx="28">
                  <c:v>2.0126E-005</c:v>
                </c:pt>
                <c:pt idx="29">
                  <c:v>2.1381E-005</c:v>
                </c:pt>
                <c:pt idx="30">
                  <c:v>2.2726E-005</c:v>
                </c:pt>
                <c:pt idx="31">
                  <c:v>2.4167E-005</c:v>
                </c:pt>
                <c:pt idx="32">
                  <c:v>2.5713E-005</c:v>
                </c:pt>
                <c:pt idx="33">
                  <c:v>2.7374E-005</c:v>
                </c:pt>
                <c:pt idx="34">
                  <c:v>2.916E-005</c:v>
                </c:pt>
                <c:pt idx="35">
                  <c:v>3.1084E-005</c:v>
                </c:pt>
                <c:pt idx="36">
                  <c:v>3.316E-005</c:v>
                </c:pt>
                <c:pt idx="37">
                  <c:v>3.5402E-005</c:v>
                </c:pt>
                <c:pt idx="38">
                  <c:v>3.7827E-005</c:v>
                </c:pt>
                <c:pt idx="39">
                  <c:v>4.0457E-005</c:v>
                </c:pt>
                <c:pt idx="40">
                  <c:v>4.3312E-005</c:v>
                </c:pt>
                <c:pt idx="41">
                  <c:v>4.6419E-005</c:v>
                </c:pt>
                <c:pt idx="42">
                  <c:v>4.9809E-005</c:v>
                </c:pt>
                <c:pt idx="43">
                  <c:v>5.3515E-005</c:v>
                </c:pt>
                <c:pt idx="44">
                  <c:v>5.758E-005</c:v>
                </c:pt>
                <c:pt idx="45">
                  <c:v>6.2051E-005</c:v>
                </c:pt>
                <c:pt idx="46">
                  <c:v>6.6987E-005</c:v>
                </c:pt>
                <c:pt idx="47">
                  <c:v>7.2457E-005</c:v>
                </c:pt>
                <c:pt idx="48">
                  <c:v>7.8544E-005</c:v>
                </c:pt>
                <c:pt idx="49">
                  <c:v>8.5354E-005</c:v>
                </c:pt>
                <c:pt idx="50">
                  <c:v>9.3011E-005</c:v>
                </c:pt>
                <c:pt idx="51">
                  <c:v>0.00010167</c:v>
                </c:pt>
                <c:pt idx="52">
                  <c:v>0.00011154</c:v>
                </c:pt>
                <c:pt idx="53">
                  <c:v>0.00012285</c:v>
                </c:pt>
                <c:pt idx="54">
                  <c:v>0.00013592</c:v>
                </c:pt>
                <c:pt idx="55">
                  <c:v>0.00015114</c:v>
                </c:pt>
                <c:pt idx="56">
                  <c:v>0.00016903</c:v>
                </c:pt>
                <c:pt idx="57">
                  <c:v>0.00019023</c:v>
                </c:pt>
                <c:pt idx="58">
                  <c:v>0.00021556</c:v>
                </c:pt>
                <c:pt idx="59">
                  <c:v>0.00024611</c:v>
                </c:pt>
                <c:pt idx="60">
                  <c:v>0.00028324</c:v>
                </c:pt>
                <c:pt idx="61">
                  <c:v>0.00032872</c:v>
                </c:pt>
                <c:pt idx="62">
                  <c:v>0.00038481</c:v>
                </c:pt>
                <c:pt idx="63">
                  <c:v>0.00045443</c:v>
                </c:pt>
                <c:pt idx="64">
                  <c:v>0.00054126</c:v>
                </c:pt>
                <c:pt idx="65">
                  <c:v>0.00064995</c:v>
                </c:pt>
                <c:pt idx="66">
                  <c:v>0.00078631</c:v>
                </c:pt>
                <c:pt idx="67">
                  <c:v>0.00095745</c:v>
                </c:pt>
                <c:pt idx="68">
                  <c:v>0.001172</c:v>
                </c:pt>
                <c:pt idx="69">
                  <c:v>0.0014398</c:v>
                </c:pt>
                <c:pt idx="70">
                  <c:v>0.001772</c:v>
                </c:pt>
                <c:pt idx="71">
                  <c:v>0.0021802</c:v>
                </c:pt>
                <c:pt idx="72">
                  <c:v>0.0026752</c:v>
                </c:pt>
                <c:pt idx="73">
                  <c:v>0.0032652</c:v>
                </c:pt>
                <c:pt idx="74">
                  <c:v>0.0039532</c:v>
                </c:pt>
                <c:pt idx="75">
                  <c:v>0.0047353</c:v>
                </c:pt>
                <c:pt idx="76">
                  <c:v>0.0055995</c:v>
                </c:pt>
                <c:pt idx="77">
                  <c:v>0.0065306</c:v>
                </c:pt>
                <c:pt idx="78">
                  <c:v>0.0075236</c:v>
                </c:pt>
                <c:pt idx="79">
                  <c:v>0.0086201</c:v>
                </c:pt>
                <c:pt idx="80">
                  <c:v>0.0099892</c:v>
                </c:pt>
                <c:pt idx="81">
                  <c:v>0.012125</c:v>
                </c:pt>
                <c:pt idx="82">
                  <c:v>0.016355</c:v>
                </c:pt>
                <c:pt idx="83">
                  <c:v>0.026192</c:v>
                </c:pt>
                <c:pt idx="84">
                  <c:v>0.051435</c:v>
                </c:pt>
                <c:pt idx="85">
                  <c:v>0.12974</c:v>
                </c:pt>
                <c:pt idx="86">
                  <c:v>0.30981</c:v>
                </c:pt>
                <c:pt idx="87">
                  <c:v>0.21908</c:v>
                </c:pt>
                <c:pt idx="88">
                  <c:v>0.065786</c:v>
                </c:pt>
                <c:pt idx="89">
                  <c:v>0.025515</c:v>
                </c:pt>
                <c:pt idx="90">
                  <c:v>0.013279</c:v>
                </c:pt>
                <c:pt idx="91">
                  <c:v>0.0081902</c:v>
                </c:pt>
                <c:pt idx="92">
                  <c:v>0.0056874</c:v>
                </c:pt>
                <c:pt idx="93">
                  <c:v>0.0042991</c:v>
                </c:pt>
                <c:pt idx="94">
                  <c:v>0.0034433</c:v>
                </c:pt>
                <c:pt idx="95">
                  <c:v>0.0028654</c:v>
                </c:pt>
                <c:pt idx="96">
                  <c:v>0.0024451</c:v>
                </c:pt>
                <c:pt idx="97">
                  <c:v>0.0021215</c:v>
                </c:pt>
                <c:pt idx="98">
                  <c:v>0.0018616</c:v>
                </c:pt>
                <c:pt idx="99">
                  <c:v>0.0016464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80071319"/>
        <c:axId val="85163825"/>
      </c:lineChart>
      <c:catAx>
        <c:axId val="80071319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85163825"/>
        <c:crosses val="autoZero"/>
        <c:auto val="1"/>
        <c:lblAlgn val="ctr"/>
        <c:lblOffset val="100"/>
        <c:noMultiLvlLbl val="0"/>
      </c:catAx>
      <c:valAx>
        <c:axId val="85163825"/>
        <c:scaling>
          <c:orientation val="minMax"/>
          <c:max val="0.3"/>
          <c:min val="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dθ/dT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80071319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SPHAERO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1"/>
                <c:pt idx="0">
                  <c:v>1.50141</c:v>
                </c:pt>
                <c:pt idx="1">
                  <c:v>1.50452</c:v>
                </c:pt>
                <c:pt idx="2">
                  <c:v>1.51048</c:v>
                </c:pt>
                <c:pt idx="3">
                  <c:v>1.52031</c:v>
                </c:pt>
                <c:pt idx="4">
                  <c:v>1.53451</c:v>
                </c:pt>
                <c:pt idx="5">
                  <c:v>1.55412</c:v>
                </c:pt>
                <c:pt idx="6">
                  <c:v>1.58015</c:v>
                </c:pt>
                <c:pt idx="7">
                  <c:v>1.61317</c:v>
                </c:pt>
                <c:pt idx="8">
                  <c:v>1.65521</c:v>
                </c:pt>
                <c:pt idx="9">
                  <c:v>1.70489</c:v>
                </c:pt>
                <c:pt idx="10">
                  <c:v>1.77117</c:v>
                </c:pt>
                <c:pt idx="11">
                  <c:v>1.85918</c:v>
                </c:pt>
                <c:pt idx="12">
                  <c:v>1.96767</c:v>
                </c:pt>
                <c:pt idx="13">
                  <c:v>2.08535</c:v>
                </c:pt>
                <c:pt idx="14">
                  <c:v>2.20731</c:v>
                </c:pt>
                <c:pt idx="15">
                  <c:v>2.32856</c:v>
                </c:pt>
                <c:pt idx="16">
                  <c:v>2.44354</c:v>
                </c:pt>
                <c:pt idx="17">
                  <c:v>2.54509</c:v>
                </c:pt>
                <c:pt idx="18">
                  <c:v>2.63256</c:v>
                </c:pt>
                <c:pt idx="19">
                  <c:v>2.71038</c:v>
                </c:pt>
                <c:pt idx="20">
                  <c:v>2.77282</c:v>
                </c:pt>
                <c:pt idx="21">
                  <c:v>2.81819</c:v>
                </c:pt>
                <c:pt idx="22">
                  <c:v>2.84166</c:v>
                </c:pt>
                <c:pt idx="23">
                  <c:v>2.84768</c:v>
                </c:pt>
                <c:pt idx="24">
                  <c:v>2.83864</c:v>
                </c:pt>
                <c:pt idx="25">
                  <c:v>2.82479</c:v>
                </c:pt>
                <c:pt idx="26">
                  <c:v>2.8134</c:v>
                </c:pt>
                <c:pt idx="27">
                  <c:v>2.80815</c:v>
                </c:pt>
                <c:pt idx="28">
                  <c:v>2.8154</c:v>
                </c:pt>
                <c:pt idx="29">
                  <c:v>2.83318</c:v>
                </c:pt>
                <c:pt idx="30">
                  <c:v>2.8534</c:v>
                </c:pt>
                <c:pt idx="31">
                  <c:v>2.86201</c:v>
                </c:pt>
                <c:pt idx="32">
                  <c:v>2.84934</c:v>
                </c:pt>
                <c:pt idx="33">
                  <c:v>2.80556</c:v>
                </c:pt>
                <c:pt idx="34">
                  <c:v>2.7234</c:v>
                </c:pt>
                <c:pt idx="35">
                  <c:v>2.60679</c:v>
                </c:pt>
                <c:pt idx="36">
                  <c:v>2.49368</c:v>
                </c:pt>
                <c:pt idx="37">
                  <c:v>2.42305</c:v>
                </c:pt>
                <c:pt idx="38">
                  <c:v>2.4002</c:v>
                </c:pt>
                <c:pt idx="39">
                  <c:v>2.39676</c:v>
                </c:pt>
                <c:pt idx="40">
                  <c:v>2.40061</c:v>
                </c:pt>
                <c:pt idx="41">
                  <c:v>2.40937</c:v>
                </c:pt>
                <c:pt idx="42">
                  <c:v>2.42364</c:v>
                </c:pt>
                <c:pt idx="43">
                  <c:v>2.44373</c:v>
                </c:pt>
                <c:pt idx="44">
                  <c:v>2.4711</c:v>
                </c:pt>
                <c:pt idx="45">
                  <c:v>2.50829</c:v>
                </c:pt>
                <c:pt idx="46">
                  <c:v>2.55625</c:v>
                </c:pt>
                <c:pt idx="47">
                  <c:v>2.61451</c:v>
                </c:pt>
                <c:pt idx="48">
                  <c:v>2.68568</c:v>
                </c:pt>
                <c:pt idx="49">
                  <c:v>2.77325</c:v>
                </c:pt>
                <c:pt idx="50">
                  <c:v>2.87682</c:v>
                </c:pt>
                <c:pt idx="51">
                  <c:v>2.9999</c:v>
                </c:pt>
                <c:pt idx="52">
                  <c:v>3.1468</c:v>
                </c:pt>
                <c:pt idx="53">
                  <c:v>3.31971</c:v>
                </c:pt>
                <c:pt idx="54">
                  <c:v>3.52258</c:v>
                </c:pt>
                <c:pt idx="55">
                  <c:v>3.7611</c:v>
                </c:pt>
                <c:pt idx="56">
                  <c:v>4.04004</c:v>
                </c:pt>
                <c:pt idx="57">
                  <c:v>4.36581</c:v>
                </c:pt>
                <c:pt idx="58">
                  <c:v>4.74544</c:v>
                </c:pt>
                <c:pt idx="59">
                  <c:v>5.18478</c:v>
                </c:pt>
                <c:pt idx="60">
                  <c:v>5.68738</c:v>
                </c:pt>
                <c:pt idx="61">
                  <c:v>6.2538</c:v>
                </c:pt>
                <c:pt idx="62">
                  <c:v>6.87714</c:v>
                </c:pt>
                <c:pt idx="63">
                  <c:v>7.54057</c:v>
                </c:pt>
                <c:pt idx="64">
                  <c:v>8.2168</c:v>
                </c:pt>
                <c:pt idx="65">
                  <c:v>8.87361</c:v>
                </c:pt>
                <c:pt idx="66">
                  <c:v>9.47295</c:v>
                </c:pt>
                <c:pt idx="67">
                  <c:v>9.9683</c:v>
                </c:pt>
                <c:pt idx="68">
                  <c:v>10.3139</c:v>
                </c:pt>
                <c:pt idx="69">
                  <c:v>10.4854</c:v>
                </c:pt>
                <c:pt idx="70">
                  <c:v>10.4894</c:v>
                </c:pt>
                <c:pt idx="71">
                  <c:v>10.3563</c:v>
                </c:pt>
                <c:pt idx="72">
                  <c:v>10.131</c:v>
                </c:pt>
                <c:pt idx="73">
                  <c:v>9.86352</c:v>
                </c:pt>
                <c:pt idx="74">
                  <c:v>9.60143</c:v>
                </c:pt>
                <c:pt idx="75">
                  <c:v>9.38267</c:v>
                </c:pt>
                <c:pt idx="76">
                  <c:v>9.22338</c:v>
                </c:pt>
                <c:pt idx="77">
                  <c:v>9.12275</c:v>
                </c:pt>
                <c:pt idx="78">
                  <c:v>9.07429</c:v>
                </c:pt>
                <c:pt idx="79">
                  <c:v>9.07096</c:v>
                </c:pt>
                <c:pt idx="80">
                  <c:v>9.10222</c:v>
                </c:pt>
                <c:pt idx="81">
                  <c:v>9.15691</c:v>
                </c:pt>
                <c:pt idx="82">
                  <c:v>9.22372</c:v>
                </c:pt>
                <c:pt idx="83">
                  <c:v>9.29025</c:v>
                </c:pt>
                <c:pt idx="84">
                  <c:v>9.34493</c:v>
                </c:pt>
                <c:pt idx="85">
                  <c:v>9.37043</c:v>
                </c:pt>
                <c:pt idx="86">
                  <c:v>9.3454</c:v>
                </c:pt>
                <c:pt idx="87">
                  <c:v>9.25407</c:v>
                </c:pt>
                <c:pt idx="88">
                  <c:v>9.07371</c:v>
                </c:pt>
                <c:pt idx="89">
                  <c:v>8.77356</c:v>
                </c:pt>
                <c:pt idx="90">
                  <c:v>8.33893</c:v>
                </c:pt>
                <c:pt idx="91">
                  <c:v>7.79867</c:v>
                </c:pt>
                <c:pt idx="92">
                  <c:v>7.20166</c:v>
                </c:pt>
                <c:pt idx="93">
                  <c:v>6.56988</c:v>
                </c:pt>
                <c:pt idx="94">
                  <c:v>5.90253</c:v>
                </c:pt>
                <c:pt idx="95">
                  <c:v>5.21259</c:v>
                </c:pt>
                <c:pt idx="96">
                  <c:v>4.53853</c:v>
                </c:pt>
                <c:pt idx="97">
                  <c:v>3.9107</c:v>
                </c:pt>
                <c:pt idx="98">
                  <c:v>3.34582</c:v>
                </c:pt>
                <c:pt idx="99">
                  <c:v>2.85033</c:v>
                </c:pt>
                <c:pt idx="100">
                  <c:v>2.42546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45883669"/>
        <c:axId val="41246268"/>
      </c:lineChart>
      <c:catAx>
        <c:axId val="45883669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41246268"/>
        <c:crosses val="autoZero"/>
        <c:auto val="1"/>
        <c:lblAlgn val="ctr"/>
        <c:lblOffset val="100"/>
        <c:noMultiLvlLbl val="0"/>
      </c:catAx>
      <c:valAx>
        <c:axId val="41246268"/>
        <c:scaling>
          <c:orientation val="minMax"/>
          <c:max val="3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Specific Heat (Kcal/Mol*K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45883669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SPHAERO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0"/>
                <c:pt idx="0">
                  <c:v>7.6241E-006</c:v>
                </c:pt>
                <c:pt idx="1">
                  <c:v>8.1187E-006</c:v>
                </c:pt>
                <c:pt idx="2">
                  <c:v>8.6452E-006</c:v>
                </c:pt>
                <c:pt idx="3">
                  <c:v>9.2058E-006</c:v>
                </c:pt>
                <c:pt idx="4">
                  <c:v>9.8031E-006</c:v>
                </c:pt>
                <c:pt idx="5">
                  <c:v>1.044E-005</c:v>
                </c:pt>
                <c:pt idx="6">
                  <c:v>1.1118E-005</c:v>
                </c:pt>
                <c:pt idx="7">
                  <c:v>1.1841E-005</c:v>
                </c:pt>
                <c:pt idx="8">
                  <c:v>1.2613E-005</c:v>
                </c:pt>
                <c:pt idx="9">
                  <c:v>1.3436E-005</c:v>
                </c:pt>
                <c:pt idx="10">
                  <c:v>1.4315E-005</c:v>
                </c:pt>
                <c:pt idx="11">
                  <c:v>1.5254E-005</c:v>
                </c:pt>
                <c:pt idx="12">
                  <c:v>1.6257E-005</c:v>
                </c:pt>
                <c:pt idx="13">
                  <c:v>1.7328E-005</c:v>
                </c:pt>
                <c:pt idx="14">
                  <c:v>1.8474E-005</c:v>
                </c:pt>
                <c:pt idx="15">
                  <c:v>1.97E-005</c:v>
                </c:pt>
                <c:pt idx="16">
                  <c:v>2.1012E-005</c:v>
                </c:pt>
                <c:pt idx="17">
                  <c:v>2.2417E-005</c:v>
                </c:pt>
                <c:pt idx="18">
                  <c:v>2.3922E-005</c:v>
                </c:pt>
                <c:pt idx="19">
                  <c:v>2.5535E-005</c:v>
                </c:pt>
                <c:pt idx="20">
                  <c:v>2.7264E-005</c:v>
                </c:pt>
                <c:pt idx="21">
                  <c:v>2.9119E-005</c:v>
                </c:pt>
                <c:pt idx="22">
                  <c:v>3.1109E-005</c:v>
                </c:pt>
                <c:pt idx="23">
                  <c:v>3.3246E-005</c:v>
                </c:pt>
                <c:pt idx="24">
                  <c:v>3.5541E-005</c:v>
                </c:pt>
                <c:pt idx="25">
                  <c:v>3.8008E-005</c:v>
                </c:pt>
                <c:pt idx="26">
                  <c:v>4.066E-005</c:v>
                </c:pt>
                <c:pt idx="27">
                  <c:v>4.3512E-005</c:v>
                </c:pt>
                <c:pt idx="28">
                  <c:v>4.6581E-005</c:v>
                </c:pt>
                <c:pt idx="29">
                  <c:v>4.9886E-005</c:v>
                </c:pt>
                <c:pt idx="30">
                  <c:v>5.3445E-005</c:v>
                </c:pt>
                <c:pt idx="31">
                  <c:v>5.728E-005</c:v>
                </c:pt>
                <c:pt idx="32">
                  <c:v>6.1414E-005</c:v>
                </c:pt>
                <c:pt idx="33">
                  <c:v>6.5872E-005</c:v>
                </c:pt>
                <c:pt idx="34">
                  <c:v>7.0684E-005</c:v>
                </c:pt>
                <c:pt idx="35">
                  <c:v>7.5878E-005</c:v>
                </c:pt>
                <c:pt idx="36">
                  <c:v>8.1488E-005</c:v>
                </c:pt>
                <c:pt idx="37">
                  <c:v>8.7551E-005</c:v>
                </c:pt>
                <c:pt idx="38">
                  <c:v>9.4107E-005</c:v>
                </c:pt>
                <c:pt idx="39">
                  <c:v>0.0001012</c:v>
                </c:pt>
                <c:pt idx="40">
                  <c:v>0.00010888</c:v>
                </c:pt>
                <c:pt idx="41">
                  <c:v>0.00011721</c:v>
                </c:pt>
                <c:pt idx="42">
                  <c:v>0.00012623</c:v>
                </c:pt>
                <c:pt idx="43">
                  <c:v>0.00013604</c:v>
                </c:pt>
                <c:pt idx="44">
                  <c:v>0.00014669</c:v>
                </c:pt>
                <c:pt idx="45">
                  <c:v>0.00015829</c:v>
                </c:pt>
                <c:pt idx="46">
                  <c:v>0.00017093</c:v>
                </c:pt>
                <c:pt idx="47">
                  <c:v>0.00018474</c:v>
                </c:pt>
                <c:pt idx="48">
                  <c:v>0.00019985</c:v>
                </c:pt>
                <c:pt idx="49">
                  <c:v>0.00021643</c:v>
                </c:pt>
                <c:pt idx="50">
                  <c:v>0.00023469</c:v>
                </c:pt>
                <c:pt idx="51">
                  <c:v>0.00025485</c:v>
                </c:pt>
                <c:pt idx="52">
                  <c:v>0.00027721</c:v>
                </c:pt>
                <c:pt idx="53">
                  <c:v>0.00030213</c:v>
                </c:pt>
                <c:pt idx="54">
                  <c:v>0.00033005</c:v>
                </c:pt>
                <c:pt idx="55">
                  <c:v>0.00036152</c:v>
                </c:pt>
                <c:pt idx="56">
                  <c:v>0.00039725</c:v>
                </c:pt>
                <c:pt idx="57">
                  <c:v>0.00043811</c:v>
                </c:pt>
                <c:pt idx="58">
                  <c:v>0.00048524</c:v>
                </c:pt>
                <c:pt idx="59">
                  <c:v>0.00054004</c:v>
                </c:pt>
                <c:pt idx="60">
                  <c:v>0.00060435</c:v>
                </c:pt>
                <c:pt idx="61">
                  <c:v>0.00068045</c:v>
                </c:pt>
                <c:pt idx="62">
                  <c:v>0.00077124</c:v>
                </c:pt>
                <c:pt idx="63">
                  <c:v>0.00088033</c:v>
                </c:pt>
                <c:pt idx="64">
                  <c:v>0.0010121</c:v>
                </c:pt>
                <c:pt idx="65">
                  <c:v>0.0011719</c:v>
                </c:pt>
                <c:pt idx="66">
                  <c:v>0.0013657</c:v>
                </c:pt>
                <c:pt idx="67">
                  <c:v>0.0016001</c:v>
                </c:pt>
                <c:pt idx="68">
                  <c:v>0.0018817</c:v>
                </c:pt>
                <c:pt idx="69">
                  <c:v>0.0022159</c:v>
                </c:pt>
                <c:pt idx="70">
                  <c:v>0.0026054</c:v>
                </c:pt>
                <c:pt idx="71">
                  <c:v>0.0030484</c:v>
                </c:pt>
                <c:pt idx="72">
                  <c:v>0.0035357</c:v>
                </c:pt>
                <c:pt idx="73">
                  <c:v>0.0040493</c:v>
                </c:pt>
                <c:pt idx="74">
                  <c:v>0.0045628</c:v>
                </c:pt>
                <c:pt idx="75">
                  <c:v>0.0050437</c:v>
                </c:pt>
                <c:pt idx="76">
                  <c:v>0.0054601</c:v>
                </c:pt>
                <c:pt idx="77">
                  <c:v>0.005789</c:v>
                </c:pt>
                <c:pt idx="78">
                  <c:v>0.0060239</c:v>
                </c:pt>
                <c:pt idx="79">
                  <c:v>0.0061795</c:v>
                </c:pt>
                <c:pt idx="80">
                  <c:v>0.006293</c:v>
                </c:pt>
                <c:pt idx="81">
                  <c:v>0.0064246</c:v>
                </c:pt>
                <c:pt idx="82">
                  <c:v>0.0066699</c:v>
                </c:pt>
                <c:pt idx="83">
                  <c:v>0.0072207</c:v>
                </c:pt>
                <c:pt idx="84">
                  <c:v>0.008653</c:v>
                </c:pt>
                <c:pt idx="85">
                  <c:v>0.013554</c:v>
                </c:pt>
                <c:pt idx="86">
                  <c:v>0.037708</c:v>
                </c:pt>
                <c:pt idx="87">
                  <c:v>0.17175</c:v>
                </c:pt>
                <c:pt idx="88">
                  <c:v>0.35389</c:v>
                </c:pt>
                <c:pt idx="89">
                  <c:v>0.16096</c:v>
                </c:pt>
                <c:pt idx="90">
                  <c:v>0.053017</c:v>
                </c:pt>
                <c:pt idx="91">
                  <c:v>0.023202</c:v>
                </c:pt>
                <c:pt idx="92">
                  <c:v>0.013192</c:v>
                </c:pt>
                <c:pt idx="93">
                  <c:v>0.0090353</c:v>
                </c:pt>
                <c:pt idx="94">
                  <c:v>0.0068761</c:v>
                </c:pt>
                <c:pt idx="95">
                  <c:v>0.0055202</c:v>
                </c:pt>
                <c:pt idx="96">
                  <c:v>0.0045535</c:v>
                </c:pt>
                <c:pt idx="97">
                  <c:v>0.0038123</c:v>
                </c:pt>
                <c:pt idx="98">
                  <c:v>0.0032218</c:v>
                </c:pt>
                <c:pt idx="99">
                  <c:v>0.0027415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14854550"/>
        <c:axId val="72915175"/>
      </c:lineChart>
      <c:catAx>
        <c:axId val="14854550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72915175"/>
        <c:crosses val="autoZero"/>
        <c:auto val="1"/>
        <c:lblAlgn val="ctr"/>
        <c:lblOffset val="100"/>
        <c:noMultiLvlLbl val="0"/>
      </c:catAx>
      <c:valAx>
        <c:axId val="72915175"/>
        <c:scaling>
          <c:orientation val="minMax"/>
          <c:max val="0.3"/>
          <c:min val="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dθ/dT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14854550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EPICHLOE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0"/>
                <c:pt idx="0">
                  <c:v>8.041E-006</c:v>
                </c:pt>
                <c:pt idx="1">
                  <c:v>8.4948E-006</c:v>
                </c:pt>
                <c:pt idx="2">
                  <c:v>8.9715E-006</c:v>
                </c:pt>
                <c:pt idx="3">
                  <c:v>9.4721E-006</c:v>
                </c:pt>
                <c:pt idx="4">
                  <c:v>9.9978E-006</c:v>
                </c:pt>
                <c:pt idx="5">
                  <c:v>1.055E-005</c:v>
                </c:pt>
                <c:pt idx="6">
                  <c:v>1.113E-005</c:v>
                </c:pt>
                <c:pt idx="7">
                  <c:v>1.1739E-005</c:v>
                </c:pt>
                <c:pt idx="8">
                  <c:v>1.2378E-005</c:v>
                </c:pt>
                <c:pt idx="9">
                  <c:v>1.3049E-005</c:v>
                </c:pt>
                <c:pt idx="10">
                  <c:v>1.3755E-005</c:v>
                </c:pt>
                <c:pt idx="11">
                  <c:v>1.4496E-005</c:v>
                </c:pt>
                <c:pt idx="12">
                  <c:v>1.5274E-005</c:v>
                </c:pt>
                <c:pt idx="13">
                  <c:v>1.6093E-005</c:v>
                </c:pt>
                <c:pt idx="14">
                  <c:v>1.6953E-005</c:v>
                </c:pt>
                <c:pt idx="15">
                  <c:v>1.7857E-005</c:v>
                </c:pt>
                <c:pt idx="16">
                  <c:v>1.8809E-005</c:v>
                </c:pt>
                <c:pt idx="17">
                  <c:v>1.981E-005</c:v>
                </c:pt>
                <c:pt idx="18">
                  <c:v>2.0864E-005</c:v>
                </c:pt>
                <c:pt idx="19">
                  <c:v>2.1974E-005</c:v>
                </c:pt>
                <c:pt idx="20">
                  <c:v>2.3144E-005</c:v>
                </c:pt>
                <c:pt idx="21">
                  <c:v>2.4378E-005</c:v>
                </c:pt>
                <c:pt idx="22">
                  <c:v>2.568E-005</c:v>
                </c:pt>
                <c:pt idx="23">
                  <c:v>2.7054E-005</c:v>
                </c:pt>
                <c:pt idx="24">
                  <c:v>2.8507E-005</c:v>
                </c:pt>
                <c:pt idx="25">
                  <c:v>3.0044E-005</c:v>
                </c:pt>
                <c:pt idx="26">
                  <c:v>3.167E-005</c:v>
                </c:pt>
                <c:pt idx="27">
                  <c:v>3.3394E-005</c:v>
                </c:pt>
                <c:pt idx="28">
                  <c:v>3.5222E-005</c:v>
                </c:pt>
                <c:pt idx="29">
                  <c:v>3.7163E-005</c:v>
                </c:pt>
                <c:pt idx="30">
                  <c:v>3.9227E-005</c:v>
                </c:pt>
                <c:pt idx="31">
                  <c:v>4.1424E-005</c:v>
                </c:pt>
                <c:pt idx="32">
                  <c:v>4.3764E-005</c:v>
                </c:pt>
                <c:pt idx="33">
                  <c:v>4.6263E-005</c:v>
                </c:pt>
                <c:pt idx="34">
                  <c:v>4.8933E-005</c:v>
                </c:pt>
                <c:pt idx="35">
                  <c:v>5.1791E-005</c:v>
                </c:pt>
                <c:pt idx="36">
                  <c:v>5.4855E-005</c:v>
                </c:pt>
                <c:pt idx="37">
                  <c:v>5.8147E-005</c:v>
                </c:pt>
                <c:pt idx="38">
                  <c:v>6.1689E-005</c:v>
                </c:pt>
                <c:pt idx="39">
                  <c:v>6.5508E-005</c:v>
                </c:pt>
                <c:pt idx="40">
                  <c:v>6.9635E-005</c:v>
                </c:pt>
                <c:pt idx="41">
                  <c:v>7.4106E-005</c:v>
                </c:pt>
                <c:pt idx="42">
                  <c:v>7.8961E-005</c:v>
                </c:pt>
                <c:pt idx="43">
                  <c:v>8.4247E-005</c:v>
                </c:pt>
                <c:pt idx="44">
                  <c:v>9.0021E-005</c:v>
                </c:pt>
                <c:pt idx="45">
                  <c:v>9.635E-005</c:v>
                </c:pt>
                <c:pt idx="46">
                  <c:v>0.00010331</c:v>
                </c:pt>
                <c:pt idx="47">
                  <c:v>0.000111</c:v>
                </c:pt>
                <c:pt idx="48">
                  <c:v>0.00011953</c:v>
                </c:pt>
                <c:pt idx="49">
                  <c:v>0.00012905</c:v>
                </c:pt>
                <c:pt idx="50">
                  <c:v>0.00013972</c:v>
                </c:pt>
                <c:pt idx="51">
                  <c:v>0.00015176</c:v>
                </c:pt>
                <c:pt idx="52">
                  <c:v>0.00016544</c:v>
                </c:pt>
                <c:pt idx="53">
                  <c:v>0.00018108</c:v>
                </c:pt>
                <c:pt idx="54">
                  <c:v>0.00019912</c:v>
                </c:pt>
                <c:pt idx="55">
                  <c:v>0.00022008</c:v>
                </c:pt>
                <c:pt idx="56">
                  <c:v>0.00024464</c:v>
                </c:pt>
                <c:pt idx="57">
                  <c:v>0.00027366</c:v>
                </c:pt>
                <c:pt idx="58">
                  <c:v>0.00030825</c:v>
                </c:pt>
                <c:pt idx="59">
                  <c:v>0.00034979</c:v>
                </c:pt>
                <c:pt idx="60">
                  <c:v>0.00040008</c:v>
                </c:pt>
                <c:pt idx="61">
                  <c:v>0.00046136</c:v>
                </c:pt>
                <c:pt idx="62">
                  <c:v>0.00053645</c:v>
                </c:pt>
                <c:pt idx="63">
                  <c:v>0.00062884</c:v>
                </c:pt>
                <c:pt idx="64">
                  <c:v>0.0007428</c:v>
                </c:pt>
                <c:pt idx="65">
                  <c:v>0.0008834</c:v>
                </c:pt>
                <c:pt idx="66">
                  <c:v>0.0010565</c:v>
                </c:pt>
                <c:pt idx="67">
                  <c:v>0.0012684</c:v>
                </c:pt>
                <c:pt idx="68">
                  <c:v>0.0015257</c:v>
                </c:pt>
                <c:pt idx="69">
                  <c:v>0.0018341</c:v>
                </c:pt>
                <c:pt idx="70">
                  <c:v>0.0021971</c:v>
                </c:pt>
                <c:pt idx="71">
                  <c:v>0.0026151</c:v>
                </c:pt>
                <c:pt idx="72">
                  <c:v>0.003083</c:v>
                </c:pt>
                <c:pt idx="73">
                  <c:v>0.0035905</c:v>
                </c:pt>
                <c:pt idx="74">
                  <c:v>0.0041239</c:v>
                </c:pt>
                <c:pt idx="75">
                  <c:v>0.0046718</c:v>
                </c:pt>
                <c:pt idx="76">
                  <c:v>0.0052391</c:v>
                </c:pt>
                <c:pt idx="77">
                  <c:v>0.0058693</c:v>
                </c:pt>
                <c:pt idx="78">
                  <c:v>0.0066829</c:v>
                </c:pt>
                <c:pt idx="79">
                  <c:v>0.0079388</c:v>
                </c:pt>
                <c:pt idx="80">
                  <c:v>0.010122</c:v>
                </c:pt>
                <c:pt idx="81">
                  <c:v>0.013999</c:v>
                </c:pt>
                <c:pt idx="82">
                  <c:v>0.020386</c:v>
                </c:pt>
                <c:pt idx="83">
                  <c:v>0.029202</c:v>
                </c:pt>
                <c:pt idx="84">
                  <c:v>0.038645</c:v>
                </c:pt>
                <c:pt idx="85">
                  <c:v>0.04928</c:v>
                </c:pt>
                <c:pt idx="86">
                  <c:v>0.082032</c:v>
                </c:pt>
                <c:pt idx="87">
                  <c:v>0.20884</c:v>
                </c:pt>
                <c:pt idx="88">
                  <c:v>0.24269</c:v>
                </c:pt>
                <c:pt idx="89">
                  <c:v>0.083511</c:v>
                </c:pt>
                <c:pt idx="90">
                  <c:v>0.030111</c:v>
                </c:pt>
                <c:pt idx="91">
                  <c:v>0.020019</c:v>
                </c:pt>
                <c:pt idx="92">
                  <c:v>0.017024</c:v>
                </c:pt>
                <c:pt idx="93">
                  <c:v>0.014726</c:v>
                </c:pt>
                <c:pt idx="94">
                  <c:v>0.012263</c:v>
                </c:pt>
                <c:pt idx="95">
                  <c:v>0.0098232</c:v>
                </c:pt>
                <c:pt idx="96">
                  <c:v>0.0076699</c:v>
                </c:pt>
                <c:pt idx="97">
                  <c:v>0.0059224</c:v>
                </c:pt>
                <c:pt idx="98">
                  <c:v>0.0045759</c:v>
                </c:pt>
                <c:pt idx="99">
                  <c:v>0.0035663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47884207"/>
        <c:axId val="86073420"/>
      </c:lineChart>
      <c:catAx>
        <c:axId val="47884207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86073420"/>
        <c:crosses val="autoZero"/>
        <c:auto val="1"/>
        <c:lblAlgn val="ctr"/>
        <c:lblOffset val="100"/>
        <c:noMultiLvlLbl val="0"/>
      </c:catAx>
      <c:valAx>
        <c:axId val="86073420"/>
        <c:scaling>
          <c:orientation val="minMax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dθ/dT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47884207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AutoShape 2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" name="AutoShape 3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" name="AutoShape 4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AutoShape 5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AutoShape 6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AutoShape 7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" name="AutoShape 8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" name="AutoShape 9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AutoShape 10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" name="AutoShape 11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AutoShape 12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AutoShape 13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AutoShape 14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-8688600" y="-15185880"/>
            <a:ext cx="24910920" cy="35980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24600" cy="4787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74"/>
              </a:spcBef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Text Box 17"/>
          <p:cNvSpPr/>
          <p:nvPr/>
        </p:nvSpPr>
        <p:spPr>
          <a:xfrm>
            <a:off x="0" y="0"/>
            <a:ext cx="3276720" cy="53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Text Box 18"/>
          <p:cNvSpPr/>
          <p:nvPr/>
        </p:nvSpPr>
        <p:spPr>
          <a:xfrm>
            <a:off x="4278240" y="0"/>
            <a:ext cx="3276720" cy="53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Text Box 19"/>
          <p:cNvSpPr/>
          <p:nvPr/>
        </p:nvSpPr>
        <p:spPr>
          <a:xfrm>
            <a:off x="0" y="10155240"/>
            <a:ext cx="3276720" cy="53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sldNum" idx="2"/>
          </p:nvPr>
        </p:nvSpPr>
        <p:spPr>
          <a:xfrm>
            <a:off x="4277880" y="10155240"/>
            <a:ext cx="3257640" cy="51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001080"/>
                <a:tab algn="l" pos="9086760"/>
                <a:tab algn="l" pos="9172440"/>
                <a:tab algn="l" pos="9258480"/>
                <a:tab algn="l" pos="9344160"/>
                <a:tab algn="l" pos="9429840"/>
                <a:tab algn="l" pos="9515520"/>
                <a:tab algn="l" pos="9601200"/>
                <a:tab algn="l" pos="9686880"/>
                <a:tab algn="l" pos="9772560"/>
                <a:tab algn="l" pos="9858240"/>
                <a:tab algn="l" pos="9944280"/>
                <a:tab algn="l" pos="10029960"/>
                <a:tab algn="l" pos="10115640"/>
                <a:tab algn="l" pos="10201320"/>
                <a:tab algn="l" pos="10287000"/>
                <a:tab algn="l" pos="10372680"/>
                <a:tab algn="l" pos="10458360"/>
                <a:tab algn="l" pos="10544040"/>
                <a:tab algn="l" pos="10630080"/>
              </a:tabLst>
              <a:defRPr b="0" lang="pt-B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001080"/>
                <a:tab algn="l" pos="9086760"/>
                <a:tab algn="l" pos="9172440"/>
                <a:tab algn="l" pos="9258480"/>
                <a:tab algn="l" pos="9344160"/>
                <a:tab algn="l" pos="9429840"/>
                <a:tab algn="l" pos="9515520"/>
                <a:tab algn="l" pos="9601200"/>
                <a:tab algn="l" pos="9686880"/>
                <a:tab algn="l" pos="9772560"/>
                <a:tab algn="l" pos="9858240"/>
                <a:tab algn="l" pos="9944280"/>
                <a:tab algn="l" pos="10029960"/>
                <a:tab algn="l" pos="10115640"/>
                <a:tab algn="l" pos="10201320"/>
                <a:tab algn="l" pos="10287000"/>
                <a:tab algn="l" pos="10372680"/>
                <a:tab algn="l" pos="10458360"/>
                <a:tab algn="l" pos="10544040"/>
                <a:tab algn="l" pos="10630080"/>
              </a:tabLst>
            </a:pPr>
            <a:fld id="{8E50352A-E229-4D38-8F40-1153B1DD71B7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Rectangle 20"/>
          <p:cNvSpPr/>
          <p:nvPr/>
        </p:nvSpPr>
        <p:spPr>
          <a:xfrm>
            <a:off x="4278240" y="10155240"/>
            <a:ext cx="325764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001080"/>
                <a:tab algn="l" pos="9086760"/>
                <a:tab algn="l" pos="9172440"/>
                <a:tab algn="l" pos="9258480"/>
                <a:tab algn="l" pos="9344160"/>
                <a:tab algn="l" pos="9429840"/>
                <a:tab algn="l" pos="9515520"/>
                <a:tab algn="l" pos="9601200"/>
                <a:tab algn="l" pos="9686880"/>
                <a:tab algn="l" pos="9772560"/>
                <a:tab algn="l" pos="9858240"/>
                <a:tab algn="l" pos="9944280"/>
                <a:tab algn="l" pos="10029960"/>
                <a:tab algn="l" pos="10115640"/>
                <a:tab algn="l" pos="10201320"/>
                <a:tab algn="l" pos="10287000"/>
                <a:tab algn="l" pos="10372680"/>
                <a:tab algn="l" pos="10458360"/>
                <a:tab algn="l" pos="10544040"/>
                <a:tab algn="l" pos="10630080"/>
              </a:tabLst>
            </a:pPr>
            <a:fld id="{1907FB82-A846-4AC0-8427-8E99C134FCE8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Text Box 1"/>
          <p:cNvSpPr/>
          <p:nvPr/>
        </p:nvSpPr>
        <p:spPr>
          <a:xfrm>
            <a:off x="4278240" y="10155240"/>
            <a:ext cx="3260880" cy="51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001080"/>
                <a:tab algn="l" pos="9086760"/>
                <a:tab algn="l" pos="9172440"/>
                <a:tab algn="l" pos="9258480"/>
                <a:tab algn="l" pos="9344160"/>
                <a:tab algn="l" pos="9429840"/>
                <a:tab algn="l" pos="9515520"/>
                <a:tab algn="l" pos="9601200"/>
                <a:tab algn="l" pos="9686880"/>
                <a:tab algn="l" pos="9772560"/>
                <a:tab algn="l" pos="9858240"/>
                <a:tab algn="l" pos="9944280"/>
                <a:tab algn="l" pos="10029960"/>
                <a:tab algn="l" pos="10115640"/>
                <a:tab algn="l" pos="10201320"/>
                <a:tab algn="l" pos="10287000"/>
                <a:tab algn="l" pos="10372680"/>
                <a:tab algn="l" pos="10458360"/>
                <a:tab algn="l" pos="10544040"/>
                <a:tab algn="l" pos="10630080"/>
              </a:tabLst>
            </a:pPr>
            <a:fld id="{03B35AEB-515F-4F6B-8AE9-04D68089E258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PlaceHolder 1"/>
          <p:cNvSpPr>
            <a:spLocks noGrp="1"/>
          </p:cNvSpPr>
          <p:nvPr>
            <p:ph type="sldImg"/>
          </p:nvPr>
        </p:nvSpPr>
        <p:spPr>
          <a:xfrm>
            <a:off x="2392200" y="812880"/>
            <a:ext cx="2773440" cy="4008240"/>
          </a:xfrm>
          <a:prstGeom prst="rect">
            <a:avLst/>
          </a:prstGeom>
          <a:ln w="0">
            <a:noFill/>
          </a:ln>
        </p:spPr>
      </p:sp>
      <p:sp>
        <p:nvSpPr>
          <p:cNvPr id="89" name="Text Box 3"/>
          <p:cNvSpPr/>
          <p:nvPr/>
        </p:nvSpPr>
        <p:spPr>
          <a:xfrm>
            <a:off x="75564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FC762F0-9520-4C89-8A3D-9F9629A571AE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61671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975280"/>
            <a:ext cx="61671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86DD481-820D-4DF3-B3C2-3D7487020C46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97528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800" y="597528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5DB02AE-5C0F-4386-96FB-3E91CD8E3C74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8200" y="231732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3680" y="231732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97528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8200" y="597528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3680" y="597528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B743E78-25F1-4208-9C5A-1CF93DAACF97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7320"/>
            <a:ext cx="616716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EAAFAD5-3658-470F-80A7-D5F96CADEF1C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616716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4E5DCD5-4321-4726-8ACE-9E1A76981E9D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E586855-3748-4486-BDD9-EAB6C4EDE964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4F4AC2F-93DF-47ED-BC40-864D04851E30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-4680"/>
            <a:ext cx="6167160" cy="11361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Aft>
                <a:spcPts val="1862"/>
              </a:spcAft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B93BA0B-A09D-4A04-A30A-BFBC45810F49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97528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8181AEC-4DFA-4873-96B4-9D79A3FCAF9E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800" y="597528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98566F9-1AB2-4BA2-95B7-59412623B655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975280"/>
            <a:ext cx="61671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842D67B-608D-4309-BDB1-B25B11E378C0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7320"/>
            <a:ext cx="616716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1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2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3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4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5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6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Text Box 3"/>
          <p:cNvSpPr/>
          <p:nvPr/>
        </p:nvSpPr>
        <p:spPr>
          <a:xfrm>
            <a:off x="343080" y="9024840"/>
            <a:ext cx="1596960" cy="68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7640" rIns="17640" tIns="9000" bIns="90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Text Box 4"/>
          <p:cNvSpPr/>
          <p:nvPr/>
        </p:nvSpPr>
        <p:spPr>
          <a:xfrm>
            <a:off x="2344680" y="9024840"/>
            <a:ext cx="2173320" cy="68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7640" rIns="17640" tIns="9000" bIns="90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4917600" y="9024480"/>
            <a:ext cx="1592280" cy="677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  <a:defRPr b="0" lang="pt-BR" sz="18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fld id="{CB27C485-5AE3-4169-8297-B8AB50369387}" type="slidenum">
              <a:rPr b="0" lang="pt-BR" sz="18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chart" Target="../charts/chart2.xml"/><Relationship Id="rId3" Type="http://schemas.openxmlformats.org/officeDocument/2006/relationships/chart" Target="../charts/chart3.xml"/><Relationship Id="rId4" Type="http://schemas.openxmlformats.org/officeDocument/2006/relationships/chart" Target="../charts/chart4.xml"/><Relationship Id="rId5" Type="http://schemas.openxmlformats.org/officeDocument/2006/relationships/chart" Target="../charts/chart5.xml"/><Relationship Id="rId6" Type="http://schemas.openxmlformats.org/officeDocument/2006/relationships/image" Target="../media/image1.png"/><Relationship Id="rId7" Type="http://schemas.openxmlformats.org/officeDocument/2006/relationships/image" Target="../media/image2.png"/><Relationship Id="rId8" Type="http://schemas.openxmlformats.org/officeDocument/2006/relationships/image" Target="../media/image3.png"/><Relationship Id="rId9" Type="http://schemas.openxmlformats.org/officeDocument/2006/relationships/image" Target="../media/image4.png"/><Relationship Id="rId10" Type="http://schemas.openxmlformats.org/officeDocument/2006/relationships/chart" Target="../charts/chart6.xml"/><Relationship Id="rId11" Type="http://schemas.openxmlformats.org/officeDocument/2006/relationships/chart" Target="../charts/chart7.xml"/><Relationship Id="rId12" Type="http://schemas.openxmlformats.org/officeDocument/2006/relationships/chart" Target="../charts/chart8.xml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2" name="Object 6"/>
          <p:cNvGraphicFramePr/>
          <p:nvPr/>
        </p:nvGraphicFramePr>
        <p:xfrm>
          <a:off x="3111480" y="2622600"/>
          <a:ext cx="1800360" cy="1251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63" name="Object 7"/>
          <p:cNvGraphicFramePr/>
          <p:nvPr/>
        </p:nvGraphicFramePr>
        <p:xfrm>
          <a:off x="3097080" y="3865680"/>
          <a:ext cx="1800360" cy="124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4" name="Object 8"/>
          <p:cNvGraphicFramePr/>
          <p:nvPr/>
        </p:nvGraphicFramePr>
        <p:xfrm>
          <a:off x="3083040" y="5067360"/>
          <a:ext cx="1800000" cy="1254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5" name="Object 10"/>
          <p:cNvGraphicFramePr/>
          <p:nvPr/>
        </p:nvGraphicFramePr>
        <p:xfrm>
          <a:off x="4854600" y="2619360"/>
          <a:ext cx="1800360" cy="1254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6" name="Object 12"/>
          <p:cNvGraphicFramePr/>
          <p:nvPr/>
        </p:nvGraphicFramePr>
        <p:xfrm>
          <a:off x="4854600" y="5060880"/>
          <a:ext cx="1800360" cy="1270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67" name="Picture 13" descr=""/>
          <p:cNvPicPr/>
          <p:nvPr/>
        </p:nvPicPr>
        <p:blipFill>
          <a:blip r:embed="rId6"/>
          <a:stretch/>
        </p:blipFill>
        <p:spPr>
          <a:xfrm>
            <a:off x="2205000" y="1568520"/>
            <a:ext cx="690480" cy="86364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14" descr=""/>
          <p:cNvPicPr/>
          <p:nvPr/>
        </p:nvPicPr>
        <p:blipFill>
          <a:blip r:embed="rId7"/>
          <a:stretch/>
        </p:blipFill>
        <p:spPr>
          <a:xfrm>
            <a:off x="2133720" y="2720880"/>
            <a:ext cx="738000" cy="92232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15" descr=""/>
          <p:cNvPicPr/>
          <p:nvPr/>
        </p:nvPicPr>
        <p:blipFill>
          <a:blip r:embed="rId8"/>
          <a:stretch/>
        </p:blipFill>
        <p:spPr>
          <a:xfrm>
            <a:off x="2060640" y="3944880"/>
            <a:ext cx="723960" cy="90648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16" descr=""/>
          <p:cNvPicPr/>
          <p:nvPr/>
        </p:nvPicPr>
        <p:blipFill>
          <a:blip r:embed="rId9"/>
          <a:stretch/>
        </p:blipFill>
        <p:spPr>
          <a:xfrm>
            <a:off x="1871640" y="5024520"/>
            <a:ext cx="765360" cy="974520"/>
          </a:xfrm>
          <a:prstGeom prst="rect">
            <a:avLst/>
          </a:prstGeom>
          <a:ln w="0">
            <a:noFill/>
          </a:ln>
        </p:spPr>
      </p:pic>
      <p:sp>
        <p:nvSpPr>
          <p:cNvPr id="71" name="Text Box 17"/>
          <p:cNvSpPr/>
          <p:nvPr/>
        </p:nvSpPr>
        <p:spPr>
          <a:xfrm>
            <a:off x="0" y="415800"/>
            <a:ext cx="685800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96920"/>
                <a:tab algn="l" pos="2084400"/>
                <a:tab algn="l" pos="2171880"/>
                <a:tab algn="l" pos="2259000"/>
                <a:tab algn="l" pos="2344680"/>
                <a:tab algn="l" pos="2432160"/>
                <a:tab algn="l" pos="2519280"/>
                <a:tab algn="l" pos="260496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  <a:tab algn="l" pos="3686040"/>
                <a:tab algn="l" pos="3772080"/>
                <a:tab algn="l" pos="3857760"/>
                <a:tab algn="l" pos="3943440"/>
                <a:tab algn="l" pos="4029120"/>
                <a:tab algn="l" pos="4114800"/>
                <a:tab algn="l" pos="4200480"/>
                <a:tab algn="l" pos="428616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Group GaRV-like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" name="Text Box 18"/>
          <p:cNvSpPr/>
          <p:nvPr/>
        </p:nvSpPr>
        <p:spPr>
          <a:xfrm>
            <a:off x="765000" y="992160"/>
            <a:ext cx="122400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Text Box 19"/>
          <p:cNvSpPr/>
          <p:nvPr/>
        </p:nvSpPr>
        <p:spPr>
          <a:xfrm>
            <a:off x="2421000" y="992160"/>
            <a:ext cx="122544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" name="Text Box 20"/>
          <p:cNvSpPr/>
          <p:nvPr/>
        </p:nvSpPr>
        <p:spPr>
          <a:xfrm>
            <a:off x="3933720" y="993600"/>
            <a:ext cx="1225800" cy="28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" name="Text Box 21"/>
          <p:cNvSpPr/>
          <p:nvPr/>
        </p:nvSpPr>
        <p:spPr>
          <a:xfrm>
            <a:off x="5695920" y="1022400"/>
            <a:ext cx="122544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" name="Text Box 22"/>
          <p:cNvSpPr/>
          <p:nvPr/>
        </p:nvSpPr>
        <p:spPr>
          <a:xfrm>
            <a:off x="3284640" y="1287360"/>
            <a:ext cx="1596960" cy="20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9000" bIns="90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1" lang="pt-BR" sz="1300" spc="-1" strike="noStrike">
                <a:solidFill>
                  <a:srgbClr val="000000"/>
                </a:solidFill>
                <a:latin typeface="Arial"/>
              </a:rPr>
              <a:t>RNAheat</a:t>
            </a:r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" name="Text Box 24"/>
          <p:cNvSpPr/>
          <p:nvPr/>
        </p:nvSpPr>
        <p:spPr>
          <a:xfrm>
            <a:off x="0" y="7756560"/>
            <a:ext cx="685800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9000" bIns="90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96920"/>
                <a:tab algn="l" pos="2084400"/>
                <a:tab algn="l" pos="2171880"/>
                <a:tab algn="l" pos="2259000"/>
                <a:tab algn="l" pos="2344680"/>
                <a:tab algn="l" pos="2432160"/>
                <a:tab algn="l" pos="2519280"/>
                <a:tab algn="l" pos="260496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  <a:tab algn="l" pos="3686040"/>
                <a:tab algn="l" pos="3772080"/>
                <a:tab algn="l" pos="3857760"/>
                <a:tab algn="l" pos="3943440"/>
                <a:tab algn="l" pos="4029120"/>
                <a:tab algn="l" pos="4114800"/>
                <a:tab algn="l" pos="4200480"/>
                <a:tab algn="l" pos="428616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Supplementary figure 2  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graphicFrame>
        <p:nvGraphicFramePr>
          <p:cNvPr id="78" name="Object 5"/>
          <p:cNvGraphicFramePr/>
          <p:nvPr/>
        </p:nvGraphicFramePr>
        <p:xfrm>
          <a:off x="3125880" y="1496880"/>
          <a:ext cx="1800000" cy="1192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79" name="Object 9"/>
          <p:cNvGraphicFramePr/>
          <p:nvPr/>
        </p:nvGraphicFramePr>
        <p:xfrm>
          <a:off x="4846680" y="1501920"/>
          <a:ext cx="1800360" cy="1218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80" name="Object 11"/>
          <p:cNvGraphicFramePr/>
          <p:nvPr/>
        </p:nvGraphicFramePr>
        <p:xfrm>
          <a:off x="4869000" y="3876840"/>
          <a:ext cx="1800000" cy="1257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81" name="Text Box 1"/>
          <p:cNvSpPr/>
          <p:nvPr/>
        </p:nvSpPr>
        <p:spPr>
          <a:xfrm>
            <a:off x="160200" y="1895400"/>
            <a:ext cx="2116440" cy="35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96920"/>
                <a:tab algn="l" pos="2084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  <a:tab algn="l" pos="3686040"/>
                <a:tab algn="l" pos="3772080"/>
              </a:tabLst>
            </a:pPr>
            <a:r>
              <a:rPr b="0" i="1" lang="pt-BR" sz="800" spc="-1" strike="noStrike">
                <a:solidFill>
                  <a:srgbClr val="000000"/>
                </a:solidFill>
                <a:latin typeface="Arial"/>
              </a:rPr>
              <a:t>Sphaeropsis sapinea RNA virus 2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96920"/>
                <a:tab algn="l" pos="2084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  <a:tab algn="l" pos="3686040"/>
                <a:tab algn="l" pos="377208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GI: 3808226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96920"/>
                <a:tab algn="l" pos="2084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  <a:tab algn="l" pos="3686040"/>
                <a:tab algn="l" pos="377208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Nt: 4439 </a:t>
            </a:r>
            <a:r>
              <a:rPr b="0" lang="pt-BR" sz="8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 4588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" name="Text Box 2"/>
          <p:cNvSpPr/>
          <p:nvPr/>
        </p:nvSpPr>
        <p:spPr>
          <a:xfrm>
            <a:off x="133200" y="3057480"/>
            <a:ext cx="1754280" cy="35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i="1" lang="pt-BR" sz="800" spc="-1" strike="noStrike">
                <a:solidFill>
                  <a:srgbClr val="000000"/>
                </a:solidFill>
                <a:latin typeface="Arial"/>
              </a:rPr>
              <a:t>Coniothyrium minitans RNA virus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GI: 78762702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Nt: 4179 </a:t>
            </a:r>
            <a:r>
              <a:rPr b="0" lang="pt-BR" sz="8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 4328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Text Box 3"/>
          <p:cNvSpPr/>
          <p:nvPr/>
        </p:nvSpPr>
        <p:spPr>
          <a:xfrm>
            <a:off x="160200" y="4284720"/>
            <a:ext cx="197820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</a:tabLst>
            </a:pPr>
            <a:r>
              <a:rPr b="0" i="1" lang="pt-BR" sz="800" spc="-1" strike="noStrike">
                <a:solidFill>
                  <a:srgbClr val="000000"/>
                </a:solidFill>
                <a:latin typeface="Arial"/>
              </a:rPr>
              <a:t>Epichloe festucae virus 1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GI: 94536498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Nt: 4355 </a:t>
            </a:r>
            <a:r>
              <a:rPr b="0" lang="pt-BR" sz="8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 4504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Text Box 4"/>
          <p:cNvSpPr/>
          <p:nvPr/>
        </p:nvSpPr>
        <p:spPr>
          <a:xfrm>
            <a:off x="160200" y="5489640"/>
            <a:ext cx="1737000" cy="4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i="1" lang="pt-BR" sz="800" spc="-1" strike="noStrike">
                <a:solidFill>
                  <a:srgbClr val="000000"/>
                </a:solidFill>
                <a:latin typeface="Arial"/>
              </a:rPr>
              <a:t>Gremmeniella abietina RNA virus L2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GI: 49036574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Nt: 4380 </a:t>
            </a:r>
            <a:r>
              <a:rPr b="0" lang="pt-BR" sz="8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 4529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Text Box 23"/>
          <p:cNvSpPr/>
          <p:nvPr/>
        </p:nvSpPr>
        <p:spPr>
          <a:xfrm>
            <a:off x="5029200" y="1292400"/>
            <a:ext cx="1568520" cy="20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9000" bIns="90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1" lang="pt-BR" sz="1300" spc="-1" strike="noStrike">
                <a:solidFill>
                  <a:srgbClr val="000000"/>
                </a:solidFill>
                <a:latin typeface="Arial"/>
              </a:rPr>
              <a:t>Meltsim</a:t>
            </a:r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5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09T20:45:45Z</dcterms:created>
  <dc:creator>Raffael</dc:creator>
  <dc:description/>
  <dc:language>en-US</dc:language>
  <cp:lastModifiedBy>Daniel</cp:lastModifiedBy>
  <dcterms:modified xsi:type="dcterms:W3CDTF">2014-07-08T18:49:47Z</dcterms:modified>
  <cp:revision>86</cp:revision>
  <dc:subject/>
  <dc:title>Slide 1</dc:title>
</cp:coreProperties>
</file>